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574"/>
    <p:restoredTop sz="94694"/>
  </p:normalViewPr>
  <p:slideViewPr>
    <p:cSldViewPr snapToGrid="0">
      <p:cViewPr varScale="1">
        <p:scale>
          <a:sx n="121" d="100"/>
          <a:sy n="121" d="100"/>
        </p:scale>
        <p:origin x="1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8343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6169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894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6635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6978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2927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061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7431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5705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874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0282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9571E1-6FE1-9844-BCC7-EE0093AE79AA}" type="datetimeFigureOut">
              <a:rPr kumimoji="1" lang="ja-JP" altLang="en-US" smtClean="0"/>
              <a:t>2026/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C73FF7-AF89-CB48-AABA-E652A617A0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0545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ィカル ユーザー インターフェイス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8CFF5198-04A0-71E0-E92E-20B78FB229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6800" y="160720"/>
            <a:ext cx="7772400" cy="529024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5E18C02-BB8F-6BB7-772D-EDF7C513E0E1}"/>
              </a:ext>
            </a:extLst>
          </p:cNvPr>
          <p:cNvSpPr txBox="1"/>
          <p:nvPr/>
        </p:nvSpPr>
        <p:spPr>
          <a:xfrm>
            <a:off x="438807" y="5145008"/>
            <a:ext cx="9346324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" altLang="ja-JP" sz="1000" dirty="0"/>
              <a:t>Figure S2. PCR analysis of strains isolated from loquat, tea, Japanese andromeda, rubber and banana using each primer set.</a:t>
            </a:r>
          </a:p>
          <a:p>
            <a:r>
              <a:rPr kumimoji="1" lang="en" altLang="ja-JP" sz="1000" dirty="0"/>
              <a:t>PCR analysis of strains of loquat, tea, Japanese andromeda, rubber and banana using the primer set </a:t>
            </a:r>
            <a:r>
              <a:rPr kumimoji="1" lang="en" altLang="ja-JP" sz="1000" dirty="0" err="1"/>
              <a:t>Pes_F</a:t>
            </a:r>
            <a:r>
              <a:rPr kumimoji="1" lang="en" altLang="ja-JP" sz="1000" dirty="0"/>
              <a:t>/R, </a:t>
            </a:r>
            <a:r>
              <a:rPr kumimoji="1" lang="en" altLang="ja-JP" sz="1000" dirty="0" err="1"/>
              <a:t>Neopes_F</a:t>
            </a:r>
            <a:r>
              <a:rPr kumimoji="1" lang="en" altLang="ja-JP" sz="1000" dirty="0"/>
              <a:t>/R and </a:t>
            </a:r>
            <a:r>
              <a:rPr kumimoji="1" lang="en" altLang="ja-JP" sz="1000" dirty="0" err="1"/>
              <a:t>Pseudopes_F</a:t>
            </a:r>
            <a:r>
              <a:rPr kumimoji="1" lang="en" altLang="ja-JP" sz="1000" dirty="0"/>
              <a:t>/R.  Strain names were shown on each lane. Each panel's first lane (M) show marker size using the </a:t>
            </a:r>
            <a:r>
              <a:rPr kumimoji="1" lang="en" altLang="ja-JP" sz="1000" dirty="0" err="1"/>
              <a:t>ExcelBand</a:t>
            </a:r>
            <a:r>
              <a:rPr kumimoji="1" lang="en" altLang="ja-JP" sz="1000" dirty="0"/>
              <a:t>™ 100 bp DNA ladder (SMOBIO). Four panels are the result of the amplification of ITS, gene12709 of </a:t>
            </a:r>
            <a:r>
              <a:rPr kumimoji="1" lang="en" altLang="ja-JP" sz="1000" i="1" dirty="0"/>
              <a:t>Pestalotiopsis</a:t>
            </a:r>
            <a:r>
              <a:rPr kumimoji="1" lang="en" altLang="ja-JP" sz="1000" dirty="0"/>
              <a:t>, gene4658 of </a:t>
            </a:r>
            <a:r>
              <a:rPr kumimoji="1" lang="en" altLang="ja-JP" sz="1000" i="1" dirty="0"/>
              <a:t>Neopestalotiopsis</a:t>
            </a:r>
            <a:r>
              <a:rPr kumimoji="1" lang="en" altLang="ja-JP" sz="1000" dirty="0"/>
              <a:t> and gene9466 of </a:t>
            </a:r>
            <a:r>
              <a:rPr kumimoji="1" lang="en" altLang="ja-JP" sz="1000" i="1" dirty="0"/>
              <a:t>Pseudopestalotiopsis</a:t>
            </a:r>
            <a:r>
              <a:rPr kumimoji="1" lang="en" altLang="ja-JP" sz="1000" dirty="0"/>
              <a:t> regions, respectively. Strains with red character indicate that the target region was amplified by the primer set </a:t>
            </a:r>
            <a:r>
              <a:rPr kumimoji="1" lang="en" altLang="ja-JP" sz="1000" dirty="0" err="1"/>
              <a:t>Pes_F</a:t>
            </a:r>
            <a:r>
              <a:rPr kumimoji="1" lang="en" altLang="ja-JP" sz="1000" dirty="0"/>
              <a:t>/R. Strains with red circle indicate that isolates were identified as </a:t>
            </a:r>
            <a:r>
              <a:rPr kumimoji="1" lang="en" altLang="ja-JP" sz="1000" i="1" dirty="0"/>
              <a:t>Pestalotiopsis</a:t>
            </a:r>
            <a:r>
              <a:rPr kumimoji="1" lang="en" altLang="ja-JP" sz="1000" dirty="0"/>
              <a:t> sp. Strains with blue character indicate that the target region was amplified by the primer set </a:t>
            </a:r>
            <a:r>
              <a:rPr kumimoji="1" lang="en" altLang="ja-JP" sz="1000" dirty="0" err="1"/>
              <a:t>Neopes_F</a:t>
            </a:r>
            <a:r>
              <a:rPr kumimoji="1" lang="en" altLang="ja-JP" sz="1000" dirty="0"/>
              <a:t>/R. Strains with blue triangle indicate that isolates were identified as </a:t>
            </a:r>
            <a:r>
              <a:rPr kumimoji="1" lang="en" altLang="ja-JP" sz="1000" i="1" dirty="0"/>
              <a:t>Neopestalotiopsis</a:t>
            </a:r>
            <a:r>
              <a:rPr kumimoji="1" lang="en" altLang="ja-JP" sz="1000" dirty="0"/>
              <a:t> sp. Strains with green character indicate that the target region was amplified by the primer set </a:t>
            </a:r>
            <a:r>
              <a:rPr kumimoji="1" lang="en" altLang="ja-JP" sz="1000" dirty="0" err="1"/>
              <a:t>Pseudopes_F</a:t>
            </a:r>
            <a:r>
              <a:rPr kumimoji="1" lang="en" altLang="ja-JP" sz="1000" dirty="0"/>
              <a:t>/R. Strains with green square indicate that isolates were identified as </a:t>
            </a:r>
            <a:r>
              <a:rPr kumimoji="1" lang="en" altLang="ja-JP" sz="1000" i="1" dirty="0"/>
              <a:t>Pseudopestalotiopsis</a:t>
            </a:r>
            <a:r>
              <a:rPr kumimoji="1" lang="en" altLang="ja-JP" sz="1000" dirty="0"/>
              <a:t> sp. Lane PC_P is positive control from TAP21H036 (</a:t>
            </a:r>
            <a:r>
              <a:rPr kumimoji="1" lang="en" altLang="ja-JP" sz="1000" i="1" dirty="0"/>
              <a:t>Pestalotiopsis</a:t>
            </a:r>
            <a:r>
              <a:rPr kumimoji="1" lang="en" altLang="ja-JP" sz="1000" dirty="0"/>
              <a:t> sp.). Lane  PC_N is positive control from TAP18N004 (</a:t>
            </a:r>
            <a:r>
              <a:rPr kumimoji="1" lang="en" altLang="ja-JP" sz="1000" i="1" dirty="0"/>
              <a:t>Neopestalotiopsis</a:t>
            </a:r>
            <a:r>
              <a:rPr kumimoji="1" lang="en" altLang="ja-JP" sz="1000" dirty="0"/>
              <a:t> sp.).  Lane PC_Ps is positive control from TAP21H021 (</a:t>
            </a:r>
            <a:r>
              <a:rPr kumimoji="1" lang="en" altLang="ja-JP" sz="1000" i="1" dirty="0"/>
              <a:t>Pseudopestalotiopsis</a:t>
            </a:r>
            <a:r>
              <a:rPr kumimoji="1" lang="en" altLang="ja-JP" sz="1000" dirty="0"/>
              <a:t> sp.). Lane NC is negative control with ddH</a:t>
            </a:r>
            <a:r>
              <a:rPr kumimoji="1" lang="en" altLang="ja-JP" sz="1000" baseline="-25000" dirty="0"/>
              <a:t>2</a:t>
            </a:r>
            <a:r>
              <a:rPr kumimoji="1" lang="en" altLang="ja-JP" sz="1000" dirty="0"/>
              <a:t>O.</a:t>
            </a:r>
            <a:endParaRPr kumimoji="1" lang="ja-JP" altLang="en-US" sz="1000"/>
          </a:p>
        </p:txBody>
      </p:sp>
    </p:spTree>
    <p:extLst>
      <p:ext uri="{BB962C8B-B14F-4D97-AF65-F5344CB8AC3E}">
        <p14:creationId xmlns:p14="http://schemas.microsoft.com/office/powerpoint/2010/main" val="3415929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265</Words>
  <Application>Microsoft Macintosh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原田 結衣</dc:creator>
  <cp:lastModifiedBy>原田 結衣</cp:lastModifiedBy>
  <cp:revision>6</cp:revision>
  <dcterms:created xsi:type="dcterms:W3CDTF">2025-04-21T12:16:06Z</dcterms:created>
  <dcterms:modified xsi:type="dcterms:W3CDTF">2026-02-23T04:01:45Z</dcterms:modified>
</cp:coreProperties>
</file>